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88FDE-269B-47E3-BEAD-79368EAD42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EEB0F6-93FA-462A-9FCE-8F8B0B1A55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E5CA5-FA36-49A6-A56F-E2531B858D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D9C34-D4FB-4A2C-BA1F-DF396626FD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587E6-8221-4BD5-B90E-64B6057AB5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FD508-D16E-4D88-89B6-856EB91CFB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9DDEB-0371-435E-80B7-8C007F12DB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27E8A-99A3-4F38-86F1-5D8FE2098A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BDE5D-7EB8-46F5-B8C7-D27571A8B0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BA6C2-5E93-4FD9-92E1-56B08F8AE1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0E195-0C73-4D35-8969-CA7237EDEC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81418-EA77-4506-AEBF-CED05AC954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F97C3B-20F1-4C2A-BFA0-14D215ED434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47640" y="1197000"/>
          <a:ext cx="6121440" cy="2736720"/>
        </p:xfrm>
        <a:graphic>
          <a:graphicData uri="http://schemas.openxmlformats.org/drawingml/2006/table">
            <a:tbl>
              <a:tblPr/>
              <a:tblGrid>
                <a:gridCol w="1320840"/>
                <a:gridCol w="959040"/>
                <a:gridCol w="960480"/>
                <a:gridCol w="960480"/>
                <a:gridCol w="960120"/>
                <a:gridCol w="960480"/>
              </a:tblGrid>
              <a:tr h="762120"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m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mx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Chk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hk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8800"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BM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7000"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N-AM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</a:tr>
              <a:tr h="658800"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P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46d0a"/>
                    </a:solidFill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1258920" y="333360"/>
            <a:ext cx="6913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% of patients with protein levels above percentile 90 of nBM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3"/>
          <p:cNvSpPr/>
          <p:nvPr/>
        </p:nvSpPr>
        <p:spPr>
          <a:xfrm>
            <a:off x="1042920" y="4365720"/>
            <a:ext cx="73454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% of patients that overexpress the examined proteins above normal threshold (a percentile 90 of nBM).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ange background- Significant overexpression (p-value&lt;0.05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01T13:25:33Z</dcterms:created>
  <dc:creator>user</dc:creator>
  <dc:description/>
  <dc:language>en-US</dc:language>
  <cp:lastModifiedBy>user</cp:lastModifiedBy>
  <dcterms:modified xsi:type="dcterms:W3CDTF">2016-04-10T18:15:54Z</dcterms:modified>
  <cp:revision>23</cp:revision>
  <dc:subject/>
  <dc:title>Slide 1</dc:title>
</cp:coreProperties>
</file>